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256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  <a:srgbClr val="C55A11"/>
    <a:srgbClr val="BDD7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80" d="100"/>
          <a:sy n="180" d="100"/>
        </p:scale>
        <p:origin x="1229" y="-268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3265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116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158068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4566700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8865545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4915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6830392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7740448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3370191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8630499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23762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445846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0494363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7989244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875416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5950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17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5610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2894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519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1490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4459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F699BE-EEB3-4D92-BF6A-D318C3551ED2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0EF546-2B8F-40DE-8ED7-0C222D16A34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2253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8107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图片 5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651" y="3348064"/>
            <a:ext cx="1828571" cy="1819048"/>
          </a:xfrm>
          <a:prstGeom prst="rect">
            <a:avLst/>
          </a:prstGeom>
        </p:spPr>
      </p:pic>
      <p:sp>
        <p:nvSpPr>
          <p:cNvPr id="34" name="TextBox 7"/>
          <p:cNvSpPr txBox="1"/>
          <p:nvPr/>
        </p:nvSpPr>
        <p:spPr>
          <a:xfrm>
            <a:off x="3628679" y="305368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4" name="TextBox 7"/>
          <p:cNvSpPr txBox="1"/>
          <p:nvPr/>
        </p:nvSpPr>
        <p:spPr>
          <a:xfrm>
            <a:off x="341840" y="304536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矩形标注 3"/>
          <p:cNvSpPr/>
          <p:nvPr/>
        </p:nvSpPr>
        <p:spPr>
          <a:xfrm>
            <a:off x="1286535" y="4026172"/>
            <a:ext cx="738604" cy="240042"/>
          </a:xfrm>
          <a:prstGeom prst="wedgeRectCallout">
            <a:avLst>
              <a:gd name="adj1" fmla="val -12084"/>
              <a:gd name="adj2" fmla="val 72088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6.98</a:t>
            </a:r>
            <a:r>
              <a:rPr kumimoji="0" lang="en-US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矩形标注 4"/>
          <p:cNvSpPr/>
          <p:nvPr/>
        </p:nvSpPr>
        <p:spPr>
          <a:xfrm>
            <a:off x="934044" y="4662300"/>
            <a:ext cx="794900" cy="191104"/>
          </a:xfrm>
          <a:prstGeom prst="wedgeRectCallout">
            <a:avLst>
              <a:gd name="adj1" fmla="val -16866"/>
              <a:gd name="adj2" fmla="val -82882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kumimoji="0" lang="en-US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2.56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矩形标注 5"/>
          <p:cNvSpPr/>
          <p:nvPr/>
        </p:nvSpPr>
        <p:spPr>
          <a:xfrm rot="19262926">
            <a:off x="430008" y="4471617"/>
            <a:ext cx="907690" cy="290343"/>
          </a:xfrm>
          <a:prstGeom prst="wedgeRectCallout">
            <a:avLst>
              <a:gd name="adj1" fmla="val 44870"/>
              <a:gd name="adj2" fmla="val -113750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8.07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15" name="组合 14"/>
          <p:cNvGrpSpPr/>
          <p:nvPr/>
        </p:nvGrpSpPr>
        <p:grpSpPr>
          <a:xfrm>
            <a:off x="2336218" y="3461468"/>
            <a:ext cx="1255295" cy="1592241"/>
            <a:chOff x="5432599" y="3504557"/>
            <a:chExt cx="1255295" cy="1592241"/>
          </a:xfrm>
        </p:grpSpPr>
        <p:sp>
          <p:nvSpPr>
            <p:cNvPr id="16" name="矩形 1"/>
            <p:cNvSpPr/>
            <p:nvPr/>
          </p:nvSpPr>
          <p:spPr>
            <a:xfrm>
              <a:off x="5432599" y="3582863"/>
              <a:ext cx="114417" cy="72310"/>
            </a:xfrm>
            <a:prstGeom prst="rect">
              <a:avLst/>
            </a:prstGeom>
            <a:solidFill>
              <a:srgbClr val="5B9BD5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5477049" y="3504557"/>
              <a:ext cx="588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INE/L1</a:t>
              </a:r>
            </a:p>
          </p:txBody>
        </p:sp>
        <p:sp>
          <p:nvSpPr>
            <p:cNvPr id="21" name="矩形 1"/>
            <p:cNvSpPr/>
            <p:nvPr/>
          </p:nvSpPr>
          <p:spPr>
            <a:xfrm>
              <a:off x="5432599" y="3718429"/>
              <a:ext cx="114416" cy="90134"/>
            </a:xfrm>
            <a:prstGeom prst="rect">
              <a:avLst/>
            </a:prstGeom>
            <a:solidFill>
              <a:srgbClr val="ED7D31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5477049" y="3657534"/>
              <a:ext cx="7142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INE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1"/>
            <p:cNvSpPr/>
            <p:nvPr/>
          </p:nvSpPr>
          <p:spPr>
            <a:xfrm>
              <a:off x="5432599" y="3871819"/>
              <a:ext cx="114416" cy="90134"/>
            </a:xfrm>
            <a:prstGeom prst="rect">
              <a:avLst/>
            </a:prstGeom>
            <a:solidFill>
              <a:srgbClr val="A5A5A5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5477050" y="3810511"/>
              <a:ext cx="714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TR/ERV1</a:t>
              </a:r>
            </a:p>
          </p:txBody>
        </p:sp>
        <p:sp>
          <p:nvSpPr>
            <p:cNvPr id="25" name="矩形 1"/>
            <p:cNvSpPr/>
            <p:nvPr/>
          </p:nvSpPr>
          <p:spPr>
            <a:xfrm>
              <a:off x="5432599" y="4025209"/>
              <a:ext cx="114416" cy="90134"/>
            </a:xfrm>
            <a:prstGeom prst="rect">
              <a:avLst/>
            </a:prstGeom>
            <a:solidFill>
              <a:srgbClr val="FFC000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5477050" y="3963488"/>
              <a:ext cx="10507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TR/ERVL-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aLR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1"/>
            <p:cNvSpPr/>
            <p:nvPr/>
          </p:nvSpPr>
          <p:spPr>
            <a:xfrm>
              <a:off x="5432599" y="4178599"/>
              <a:ext cx="114416" cy="90134"/>
            </a:xfrm>
            <a:prstGeom prst="rect">
              <a:avLst/>
            </a:prstGeom>
            <a:solidFill>
              <a:srgbClr val="4472C4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5477050" y="4116465"/>
              <a:ext cx="588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INE/L2</a:t>
              </a:r>
            </a:p>
          </p:txBody>
        </p:sp>
        <p:sp>
          <p:nvSpPr>
            <p:cNvPr id="29" name="矩形 1"/>
            <p:cNvSpPr/>
            <p:nvPr/>
          </p:nvSpPr>
          <p:spPr>
            <a:xfrm>
              <a:off x="5432599" y="4331989"/>
              <a:ext cx="114416" cy="90134"/>
            </a:xfrm>
            <a:prstGeom prst="rect">
              <a:avLst/>
            </a:prstGeom>
            <a:solidFill>
              <a:srgbClr val="70AD47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5477050" y="4269442"/>
              <a:ext cx="8729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Simple_repea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 1"/>
            <p:cNvSpPr/>
            <p:nvPr/>
          </p:nvSpPr>
          <p:spPr>
            <a:xfrm>
              <a:off x="5432599" y="4485379"/>
              <a:ext cx="114416" cy="90134"/>
            </a:xfrm>
            <a:prstGeom prst="rect">
              <a:avLst/>
            </a:prstGeom>
            <a:solidFill>
              <a:srgbClr val="255E91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5477049" y="4422419"/>
              <a:ext cx="1210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tellite/centromere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矩形 1"/>
            <p:cNvSpPr/>
            <p:nvPr/>
          </p:nvSpPr>
          <p:spPr>
            <a:xfrm>
              <a:off x="5432599" y="4638769"/>
              <a:ext cx="114416" cy="90134"/>
            </a:xfrm>
            <a:prstGeom prst="rect">
              <a:avLst/>
            </a:prstGeom>
            <a:solidFill>
              <a:srgbClr val="9E480E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5477050" y="4575396"/>
              <a:ext cx="714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TR/ERVL</a:t>
              </a:r>
            </a:p>
          </p:txBody>
        </p:sp>
        <p:sp>
          <p:nvSpPr>
            <p:cNvPr id="36" name="矩形 1"/>
            <p:cNvSpPr/>
            <p:nvPr/>
          </p:nvSpPr>
          <p:spPr>
            <a:xfrm>
              <a:off x="5432599" y="4792159"/>
              <a:ext cx="114416" cy="90134"/>
            </a:xfrm>
            <a:prstGeom prst="rect">
              <a:avLst/>
            </a:prstGeom>
            <a:solidFill>
              <a:srgbClr val="636363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5477050" y="4728373"/>
              <a:ext cx="714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INE/MIR</a:t>
              </a:r>
            </a:p>
          </p:txBody>
        </p:sp>
        <p:sp>
          <p:nvSpPr>
            <p:cNvPr id="38" name="矩形 1"/>
            <p:cNvSpPr/>
            <p:nvPr/>
          </p:nvSpPr>
          <p:spPr>
            <a:xfrm>
              <a:off x="5432599" y="4945551"/>
              <a:ext cx="114416" cy="90134"/>
            </a:xfrm>
            <a:prstGeom prst="rect">
              <a:avLst/>
            </a:prstGeom>
            <a:solidFill>
              <a:srgbClr val="997300"/>
            </a:solidFill>
            <a:ln w="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>
                <a:defRPr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defTabSz="914362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5477050" y="4881354"/>
              <a:ext cx="714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ther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" name="矩形标注 39"/>
          <p:cNvSpPr/>
          <p:nvPr/>
        </p:nvSpPr>
        <p:spPr>
          <a:xfrm rot="20106377">
            <a:off x="233000" y="4281667"/>
            <a:ext cx="907690" cy="290343"/>
          </a:xfrm>
          <a:prstGeom prst="wedgeRectCallout">
            <a:avLst>
              <a:gd name="adj1" fmla="val 44870"/>
              <a:gd name="adj2" fmla="val -113750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5.95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3695355" y="3185740"/>
            <a:ext cx="3205420" cy="2085801"/>
            <a:chOff x="3695355" y="3185740"/>
            <a:chExt cx="3205420" cy="2085801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95355" y="3356184"/>
              <a:ext cx="1771429" cy="1771429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4768850" y="4080021"/>
              <a:ext cx="4369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51</a:t>
              </a: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%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3797431" y="4038210"/>
              <a:ext cx="70815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7%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294953" y="3185740"/>
              <a:ext cx="653194" cy="215444"/>
            </a:xfrm>
            <a:prstGeom prst="rect">
              <a:avLst/>
            </a:prstGeom>
            <a:noFill/>
            <a:ln w="15875"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%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4243297" y="5056097"/>
              <a:ext cx="363573" cy="215444"/>
            </a:xfrm>
            <a:prstGeom prst="rect">
              <a:avLst/>
            </a:prstGeom>
            <a:noFill/>
            <a:ln w="15875">
              <a:noFill/>
            </a:ln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</a:t>
              </a: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%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41" name="组合 40"/>
            <p:cNvGrpSpPr/>
            <p:nvPr/>
          </p:nvGrpSpPr>
          <p:grpSpPr>
            <a:xfrm>
              <a:off x="5570625" y="3905576"/>
              <a:ext cx="1330150" cy="672644"/>
              <a:chOff x="2210490" y="3904607"/>
              <a:chExt cx="1330150" cy="672644"/>
            </a:xfrm>
          </p:grpSpPr>
          <p:sp>
            <p:nvSpPr>
              <p:cNvPr id="42" name="文本框 41"/>
              <p:cNvSpPr txBox="1"/>
              <p:nvPr/>
            </p:nvSpPr>
            <p:spPr>
              <a:xfrm>
                <a:off x="2255993" y="3904607"/>
                <a:ext cx="897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peatMasker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矩形 1"/>
              <p:cNvSpPr/>
              <p:nvPr/>
            </p:nvSpPr>
            <p:spPr>
              <a:xfrm>
                <a:off x="2210490" y="3981534"/>
                <a:ext cx="114417" cy="72310"/>
              </a:xfrm>
              <a:prstGeom prst="rect">
                <a:avLst/>
              </a:prstGeom>
              <a:solidFill>
                <a:srgbClr val="BDD7EE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lvl1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914362"/>
                <a:endParaRPr lang="zh-CN" altLang="en-US">
                  <a:solidFill>
                    <a:prstClr val="white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/>
              <p:cNvSpPr txBox="1"/>
              <p:nvPr/>
            </p:nvSpPr>
            <p:spPr>
              <a:xfrm>
                <a:off x="2255993" y="4057007"/>
                <a:ext cx="12846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CRs &amp; </a:t>
                </a:r>
                <a:r>
                  <a:rPr lang="en-US" altLang="zh-CN" sz="8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peatMasker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矩形 1"/>
              <p:cNvSpPr/>
              <p:nvPr/>
            </p:nvSpPr>
            <p:spPr>
              <a:xfrm>
                <a:off x="2210490" y="4133934"/>
                <a:ext cx="114417" cy="72310"/>
              </a:xfrm>
              <a:prstGeom prst="rect">
                <a:avLst/>
              </a:prstGeom>
              <a:solidFill>
                <a:srgbClr val="C55A11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lvl1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914362"/>
                <a:endParaRPr lang="zh-CN" altLang="en-US">
                  <a:solidFill>
                    <a:prstClr val="white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6" name="文本框 45"/>
              <p:cNvSpPr txBox="1"/>
              <p:nvPr/>
            </p:nvSpPr>
            <p:spPr>
              <a:xfrm>
                <a:off x="2255993" y="4209407"/>
                <a:ext cx="897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either</a:t>
                </a:r>
              </a:p>
            </p:txBody>
          </p:sp>
          <p:sp>
            <p:nvSpPr>
              <p:cNvPr id="47" name="矩形 1"/>
              <p:cNvSpPr/>
              <p:nvPr/>
            </p:nvSpPr>
            <p:spPr>
              <a:xfrm>
                <a:off x="2210490" y="4286334"/>
                <a:ext cx="114417" cy="72310"/>
              </a:xfrm>
              <a:prstGeom prst="rect">
                <a:avLst/>
              </a:prstGeom>
              <a:solidFill>
                <a:srgbClr val="D0CECE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lvl1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914362"/>
                <a:endParaRPr lang="zh-CN" altLang="en-US">
                  <a:solidFill>
                    <a:prstClr val="white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2255993" y="4361807"/>
                <a:ext cx="89724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>
                  <a:defRPr/>
                </a:pPr>
                <a:r>
                  <a:rPr lang="en-US" altLang="zh-CN" sz="8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CRs</a:t>
                </a:r>
              </a:p>
            </p:txBody>
          </p:sp>
          <p:sp>
            <p:nvSpPr>
              <p:cNvPr id="49" name="矩形 1"/>
              <p:cNvSpPr/>
              <p:nvPr/>
            </p:nvSpPr>
            <p:spPr>
              <a:xfrm>
                <a:off x="2210490" y="4438734"/>
                <a:ext cx="114417" cy="7231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lvl1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>
                  <a:defRPr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defTabSz="914362"/>
                <a:endParaRPr lang="zh-CN" altLang="en-US">
                  <a:solidFill>
                    <a:prstClr val="white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0" name="矩形标注 49"/>
          <p:cNvSpPr/>
          <p:nvPr/>
        </p:nvSpPr>
        <p:spPr>
          <a:xfrm>
            <a:off x="116677" y="4096726"/>
            <a:ext cx="907690" cy="290343"/>
          </a:xfrm>
          <a:prstGeom prst="wedgeRectCallout">
            <a:avLst>
              <a:gd name="adj1" fmla="val 44870"/>
              <a:gd name="adj2" fmla="val -113750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b="1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.62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1" name="矩形标注 50"/>
          <p:cNvSpPr/>
          <p:nvPr/>
        </p:nvSpPr>
        <p:spPr>
          <a:xfrm rot="633451">
            <a:off x="135813" y="3938704"/>
            <a:ext cx="907690" cy="290343"/>
          </a:xfrm>
          <a:prstGeom prst="wedgeRectCallout">
            <a:avLst>
              <a:gd name="adj1" fmla="val 44870"/>
              <a:gd name="adj2" fmla="val -113750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b="1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.22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3" name="矩形标注 52"/>
          <p:cNvSpPr/>
          <p:nvPr/>
        </p:nvSpPr>
        <p:spPr>
          <a:xfrm rot="1100879">
            <a:off x="198331" y="3806833"/>
            <a:ext cx="907690" cy="290343"/>
          </a:xfrm>
          <a:prstGeom prst="wedgeRectCallout">
            <a:avLst>
              <a:gd name="adj1" fmla="val 44870"/>
              <a:gd name="adj2" fmla="val -113750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b="1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.19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4" name="矩形标注 53"/>
          <p:cNvSpPr/>
          <p:nvPr/>
        </p:nvSpPr>
        <p:spPr>
          <a:xfrm rot="1823578">
            <a:off x="263488" y="3683557"/>
            <a:ext cx="907690" cy="290343"/>
          </a:xfrm>
          <a:prstGeom prst="wedgeRectCallout">
            <a:avLst>
              <a:gd name="adj1" fmla="val 44870"/>
              <a:gd name="adj2" fmla="val -113750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b="1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3.01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5" name="矩形标注 54"/>
          <p:cNvSpPr/>
          <p:nvPr/>
        </p:nvSpPr>
        <p:spPr>
          <a:xfrm rot="2826202">
            <a:off x="336018" y="3575219"/>
            <a:ext cx="907690" cy="290343"/>
          </a:xfrm>
          <a:prstGeom prst="wedgeRectCallout">
            <a:avLst>
              <a:gd name="adj1" fmla="val 44870"/>
              <a:gd name="adj2" fmla="val -113750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b="1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.82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6" name="矩形标注 55"/>
          <p:cNvSpPr/>
          <p:nvPr/>
        </p:nvSpPr>
        <p:spPr>
          <a:xfrm rot="3845300">
            <a:off x="616011" y="3469273"/>
            <a:ext cx="907690" cy="290343"/>
          </a:xfrm>
          <a:prstGeom prst="wedgeRectCallout">
            <a:avLst>
              <a:gd name="adj1" fmla="val 44870"/>
              <a:gd name="adj2" fmla="val -113750"/>
            </a:avLst>
          </a:prstGeom>
          <a:noFill/>
          <a:ln w="158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800" b="1" noProof="0" dirty="0" smtClean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10.59</a:t>
            </a:r>
            <a:r>
              <a:rPr kumimoji="0" lang="en-US" altLang="zh-CN" sz="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%</a:t>
            </a:r>
            <a:endParaRPr kumimoji="0" lang="zh-CN" altLang="en-US" sz="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43573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</TotalTime>
  <Words>48</Words>
  <Application>Microsoft Office PowerPoint</Application>
  <PresentationFormat>A4 纸张(210x297 毫米)</PresentationFormat>
  <Paragraphs>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Office 主题​​</vt:lpstr>
      <vt:lpstr>1_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艳芳</dc:creator>
  <cp:lastModifiedBy>焦玉霞</cp:lastModifiedBy>
  <cp:revision>27</cp:revision>
  <dcterms:created xsi:type="dcterms:W3CDTF">2018-12-08T09:04:51Z</dcterms:created>
  <dcterms:modified xsi:type="dcterms:W3CDTF">2020-08-10T13:19:04Z</dcterms:modified>
</cp:coreProperties>
</file>